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D3356C3-FD50-4A23-AF9D-BC23425A8949}" type="slidenum">
              <a:rPr b="0" lang="de-DE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11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Foliennummernplatzhalt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9C40D4-27D5-4E39-8847-8554B416510E}" type="slidenum">
              <a:rPr b="0" lang="de-DE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050655-6207-4BC7-81AC-158E45FA866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6556D3-DE0B-4E5D-9230-87793CDB57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042663-4D91-4A21-ADF6-65A59187BD6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5885D1-336B-4249-A80D-34E20BBE914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1EC96D-DA44-4C2C-85BA-34C134ECE65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2336E7-A1CF-4F6A-8A6C-26B2FDBA54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47B952-DE94-4039-B9D3-4A14BA4CF7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A8FA56-6859-49EE-8B13-4AC53B165D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91A62B-D544-4FAA-B042-4A79C9807C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85E131-BCC5-48C0-AA38-E89C94CB85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897406-55AA-48AA-9BD1-EF029CBE9D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4BBB89-9F14-4DD8-BF66-97FA97AB88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086D538-0D97-4919-99E4-FE9C9E07E0A1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feld 72"/>
          <p:cNvSpPr/>
          <p:nvPr/>
        </p:nvSpPr>
        <p:spPr>
          <a:xfrm>
            <a:off x="5751360" y="9398160"/>
            <a:ext cx="110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feld 72"/>
          <p:cNvSpPr/>
          <p:nvPr/>
        </p:nvSpPr>
        <p:spPr>
          <a:xfrm>
            <a:off x="260280" y="272880"/>
            <a:ext cx="388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supporting dat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59" descr=""/>
          <p:cNvPicPr/>
          <p:nvPr/>
        </p:nvPicPr>
        <p:blipFill>
          <a:blip r:embed="rId1"/>
          <a:srcRect l="15382" t="9609" r="60517" b="49960"/>
          <a:stretch/>
        </p:blipFill>
        <p:spPr>
          <a:xfrm>
            <a:off x="581040" y="1757520"/>
            <a:ext cx="2952720" cy="17287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51" name="Rectangle 19"/>
          <p:cNvSpPr/>
          <p:nvPr/>
        </p:nvSpPr>
        <p:spPr>
          <a:xfrm>
            <a:off x="5000760" y="2327400"/>
            <a:ext cx="360360" cy="1027080"/>
          </a:xfrm>
          <a:prstGeom prst="rect">
            <a:avLst/>
          </a:prstGeom>
          <a:solidFill>
            <a:srgbClr val="7f7f7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20"/>
          <p:cNvSpPr/>
          <p:nvPr/>
        </p:nvSpPr>
        <p:spPr>
          <a:xfrm>
            <a:off x="5000760" y="2327400"/>
            <a:ext cx="504720" cy="102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21"/>
          <p:cNvSpPr/>
          <p:nvPr/>
        </p:nvSpPr>
        <p:spPr>
          <a:xfrm>
            <a:off x="5575320" y="2378160"/>
            <a:ext cx="360360" cy="97632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22"/>
          <p:cNvSpPr/>
          <p:nvPr/>
        </p:nvSpPr>
        <p:spPr>
          <a:xfrm>
            <a:off x="5622840" y="2378160"/>
            <a:ext cx="514440" cy="9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23"/>
          <p:cNvSpPr/>
          <p:nvPr/>
        </p:nvSpPr>
        <p:spPr>
          <a:xfrm>
            <a:off x="6138720" y="2077920"/>
            <a:ext cx="360360" cy="12765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25"/>
          <p:cNvSpPr/>
          <p:nvPr/>
        </p:nvSpPr>
        <p:spPr>
          <a:xfrm flipV="1">
            <a:off x="5172120" y="2222280"/>
            <a:ext cx="0" cy="1047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26"/>
          <p:cNvSpPr/>
          <p:nvPr/>
        </p:nvSpPr>
        <p:spPr>
          <a:xfrm>
            <a:off x="5086440" y="2222640"/>
            <a:ext cx="179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27"/>
          <p:cNvSpPr/>
          <p:nvPr/>
        </p:nvSpPr>
        <p:spPr>
          <a:xfrm flipV="1">
            <a:off x="5746680" y="2357280"/>
            <a:ext cx="0" cy="20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28"/>
          <p:cNvSpPr/>
          <p:nvPr/>
        </p:nvSpPr>
        <p:spPr>
          <a:xfrm>
            <a:off x="5661000" y="2349360"/>
            <a:ext cx="181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29"/>
          <p:cNvSpPr/>
          <p:nvPr/>
        </p:nvSpPr>
        <p:spPr>
          <a:xfrm flipV="1">
            <a:off x="6310440" y="1890720"/>
            <a:ext cx="0" cy="187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30"/>
          <p:cNvSpPr/>
          <p:nvPr/>
        </p:nvSpPr>
        <p:spPr>
          <a:xfrm>
            <a:off x="6224760" y="1890720"/>
            <a:ext cx="180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31"/>
          <p:cNvSpPr/>
          <p:nvPr/>
        </p:nvSpPr>
        <p:spPr>
          <a:xfrm>
            <a:off x="4773600" y="1714680"/>
            <a:ext cx="0" cy="1639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32"/>
          <p:cNvSpPr/>
          <p:nvPr/>
        </p:nvSpPr>
        <p:spPr>
          <a:xfrm>
            <a:off x="4735440" y="3354480"/>
            <a:ext cx="38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33"/>
          <p:cNvSpPr/>
          <p:nvPr/>
        </p:nvSpPr>
        <p:spPr>
          <a:xfrm>
            <a:off x="4735440" y="3146400"/>
            <a:ext cx="38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34"/>
          <p:cNvSpPr/>
          <p:nvPr/>
        </p:nvSpPr>
        <p:spPr>
          <a:xfrm>
            <a:off x="4735440" y="2949480"/>
            <a:ext cx="38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35"/>
          <p:cNvSpPr/>
          <p:nvPr/>
        </p:nvSpPr>
        <p:spPr>
          <a:xfrm>
            <a:off x="4735440" y="2741760"/>
            <a:ext cx="38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36"/>
          <p:cNvSpPr/>
          <p:nvPr/>
        </p:nvSpPr>
        <p:spPr>
          <a:xfrm>
            <a:off x="4735440" y="2533680"/>
            <a:ext cx="38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37"/>
          <p:cNvSpPr/>
          <p:nvPr/>
        </p:nvSpPr>
        <p:spPr>
          <a:xfrm>
            <a:off x="4735440" y="2327400"/>
            <a:ext cx="38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38"/>
          <p:cNvSpPr/>
          <p:nvPr/>
        </p:nvSpPr>
        <p:spPr>
          <a:xfrm>
            <a:off x="4735440" y="2128680"/>
            <a:ext cx="38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39"/>
          <p:cNvSpPr/>
          <p:nvPr/>
        </p:nvSpPr>
        <p:spPr>
          <a:xfrm>
            <a:off x="4735440" y="1922400"/>
            <a:ext cx="38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40"/>
          <p:cNvSpPr/>
          <p:nvPr/>
        </p:nvSpPr>
        <p:spPr>
          <a:xfrm>
            <a:off x="4735440" y="1714680"/>
            <a:ext cx="38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41"/>
          <p:cNvSpPr/>
          <p:nvPr/>
        </p:nvSpPr>
        <p:spPr>
          <a:xfrm>
            <a:off x="4773600" y="3354480"/>
            <a:ext cx="180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43"/>
          <p:cNvSpPr/>
          <p:nvPr/>
        </p:nvSpPr>
        <p:spPr>
          <a:xfrm>
            <a:off x="4623120" y="32814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612720"/>
                <a:tab algn="l" pos="1225440"/>
                <a:tab algn="l" pos="1838160"/>
                <a:tab algn="l" pos="2451240"/>
                <a:tab algn="l" pos="3063960"/>
                <a:tab algn="l" pos="3676680"/>
                <a:tab algn="l" pos="4289400"/>
                <a:tab algn="l" pos="4902120"/>
                <a:tab algn="l" pos="5514840"/>
                <a:tab algn="l" pos="6127920"/>
                <a:tab algn="l" pos="6740640"/>
                <a:tab algn="l" pos="7353360"/>
                <a:tab algn="l" pos="7966080"/>
                <a:tab algn="l" pos="8578800"/>
                <a:tab algn="l" pos="9191520"/>
                <a:tab algn="l" pos="9804240"/>
                <a:tab algn="l" pos="1041732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44"/>
          <p:cNvSpPr/>
          <p:nvPr/>
        </p:nvSpPr>
        <p:spPr>
          <a:xfrm>
            <a:off x="4517280" y="30751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612720"/>
                <a:tab algn="l" pos="1225440"/>
                <a:tab algn="l" pos="1838160"/>
                <a:tab algn="l" pos="2451240"/>
                <a:tab algn="l" pos="3063960"/>
                <a:tab algn="l" pos="3676680"/>
                <a:tab algn="l" pos="4289400"/>
                <a:tab algn="l" pos="4902120"/>
                <a:tab algn="l" pos="5514840"/>
                <a:tab algn="l" pos="6127920"/>
                <a:tab algn="l" pos="6740640"/>
                <a:tab algn="l" pos="7353360"/>
                <a:tab algn="l" pos="7966080"/>
                <a:tab algn="l" pos="8578800"/>
                <a:tab algn="l" pos="9191520"/>
                <a:tab algn="l" pos="9804240"/>
                <a:tab algn="l" pos="1041732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45"/>
          <p:cNvSpPr/>
          <p:nvPr/>
        </p:nvSpPr>
        <p:spPr>
          <a:xfrm>
            <a:off x="4517280" y="28764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612720"/>
                <a:tab algn="l" pos="1225440"/>
                <a:tab algn="l" pos="1838160"/>
                <a:tab algn="l" pos="2451240"/>
                <a:tab algn="l" pos="3063960"/>
                <a:tab algn="l" pos="3676680"/>
                <a:tab algn="l" pos="4289400"/>
                <a:tab algn="l" pos="4902120"/>
                <a:tab algn="l" pos="5514840"/>
                <a:tab algn="l" pos="6127920"/>
                <a:tab algn="l" pos="6740640"/>
                <a:tab algn="l" pos="7353360"/>
                <a:tab algn="l" pos="7966080"/>
                <a:tab algn="l" pos="8578800"/>
                <a:tab algn="l" pos="9191520"/>
                <a:tab algn="l" pos="9804240"/>
                <a:tab algn="l" pos="1041732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46"/>
          <p:cNvSpPr/>
          <p:nvPr/>
        </p:nvSpPr>
        <p:spPr>
          <a:xfrm>
            <a:off x="4517280" y="266868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612720"/>
                <a:tab algn="l" pos="1225440"/>
                <a:tab algn="l" pos="1838160"/>
                <a:tab algn="l" pos="2451240"/>
                <a:tab algn="l" pos="3063960"/>
                <a:tab algn="l" pos="3676680"/>
                <a:tab algn="l" pos="4289400"/>
                <a:tab algn="l" pos="4902120"/>
                <a:tab algn="l" pos="5514840"/>
                <a:tab algn="l" pos="6127920"/>
                <a:tab algn="l" pos="6740640"/>
                <a:tab algn="l" pos="7353360"/>
                <a:tab algn="l" pos="7966080"/>
                <a:tab algn="l" pos="8578800"/>
                <a:tab algn="l" pos="9191520"/>
                <a:tab algn="l" pos="9804240"/>
                <a:tab algn="l" pos="1041732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47"/>
          <p:cNvSpPr/>
          <p:nvPr/>
        </p:nvSpPr>
        <p:spPr>
          <a:xfrm>
            <a:off x="4517280" y="246204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612720"/>
                <a:tab algn="l" pos="1225440"/>
                <a:tab algn="l" pos="1838160"/>
                <a:tab algn="l" pos="2451240"/>
                <a:tab algn="l" pos="3063960"/>
                <a:tab algn="l" pos="3676680"/>
                <a:tab algn="l" pos="4289400"/>
                <a:tab algn="l" pos="4902120"/>
                <a:tab algn="l" pos="5514840"/>
                <a:tab algn="l" pos="6127920"/>
                <a:tab algn="l" pos="6740640"/>
                <a:tab algn="l" pos="7353360"/>
                <a:tab algn="l" pos="7966080"/>
                <a:tab algn="l" pos="8578800"/>
                <a:tab algn="l" pos="9191520"/>
                <a:tab algn="l" pos="9804240"/>
                <a:tab algn="l" pos="1041732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48"/>
          <p:cNvSpPr/>
          <p:nvPr/>
        </p:nvSpPr>
        <p:spPr>
          <a:xfrm>
            <a:off x="4517280" y="22543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612720"/>
                <a:tab algn="l" pos="1225440"/>
                <a:tab algn="l" pos="1838160"/>
                <a:tab algn="l" pos="2451240"/>
                <a:tab algn="l" pos="3063960"/>
                <a:tab algn="l" pos="3676680"/>
                <a:tab algn="l" pos="4289400"/>
                <a:tab algn="l" pos="4902120"/>
                <a:tab algn="l" pos="5514840"/>
                <a:tab algn="l" pos="6127920"/>
                <a:tab algn="l" pos="6740640"/>
                <a:tab algn="l" pos="7353360"/>
                <a:tab algn="l" pos="7966080"/>
                <a:tab algn="l" pos="8578800"/>
                <a:tab algn="l" pos="9191520"/>
                <a:tab algn="l" pos="9804240"/>
                <a:tab algn="l" pos="1041732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49"/>
          <p:cNvSpPr/>
          <p:nvPr/>
        </p:nvSpPr>
        <p:spPr>
          <a:xfrm>
            <a:off x="4517280" y="20574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612720"/>
                <a:tab algn="l" pos="1225440"/>
                <a:tab algn="l" pos="1838160"/>
                <a:tab algn="l" pos="2451240"/>
                <a:tab algn="l" pos="3063960"/>
                <a:tab algn="l" pos="3676680"/>
                <a:tab algn="l" pos="4289400"/>
                <a:tab algn="l" pos="4902120"/>
                <a:tab algn="l" pos="5514840"/>
                <a:tab algn="l" pos="6127920"/>
                <a:tab algn="l" pos="6740640"/>
                <a:tab algn="l" pos="7353360"/>
                <a:tab algn="l" pos="7966080"/>
                <a:tab algn="l" pos="8578800"/>
                <a:tab algn="l" pos="9191520"/>
                <a:tab algn="l" pos="9804240"/>
                <a:tab algn="l" pos="1041732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1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50"/>
          <p:cNvSpPr/>
          <p:nvPr/>
        </p:nvSpPr>
        <p:spPr>
          <a:xfrm>
            <a:off x="4517280" y="18493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612720"/>
                <a:tab algn="l" pos="1225440"/>
                <a:tab algn="l" pos="1838160"/>
                <a:tab algn="l" pos="2451240"/>
                <a:tab algn="l" pos="3063960"/>
                <a:tab algn="l" pos="3676680"/>
                <a:tab algn="l" pos="4289400"/>
                <a:tab algn="l" pos="4902120"/>
                <a:tab algn="l" pos="5514840"/>
                <a:tab algn="l" pos="6127920"/>
                <a:tab algn="l" pos="6740640"/>
                <a:tab algn="l" pos="7353360"/>
                <a:tab algn="l" pos="7966080"/>
                <a:tab algn="l" pos="8578800"/>
                <a:tab algn="l" pos="9191520"/>
                <a:tab algn="l" pos="9804240"/>
                <a:tab algn="l" pos="1041732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1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51"/>
          <p:cNvSpPr/>
          <p:nvPr/>
        </p:nvSpPr>
        <p:spPr>
          <a:xfrm>
            <a:off x="4517280" y="16416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612720"/>
                <a:tab algn="l" pos="1225440"/>
                <a:tab algn="l" pos="1838160"/>
                <a:tab algn="l" pos="2451240"/>
                <a:tab algn="l" pos="3063960"/>
                <a:tab algn="l" pos="3676680"/>
                <a:tab algn="l" pos="4289400"/>
                <a:tab algn="l" pos="4902120"/>
                <a:tab algn="l" pos="5514840"/>
                <a:tab algn="l" pos="6127920"/>
                <a:tab algn="l" pos="6740640"/>
                <a:tab algn="l" pos="7353360"/>
                <a:tab algn="l" pos="7966080"/>
                <a:tab algn="l" pos="8578800"/>
                <a:tab algn="l" pos="9191520"/>
                <a:tab algn="l" pos="9804240"/>
                <a:tab algn="l" pos="1041732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1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52"/>
          <p:cNvSpPr/>
          <p:nvPr/>
        </p:nvSpPr>
        <p:spPr>
          <a:xfrm rot="19113000">
            <a:off x="5005800" y="3491280"/>
            <a:ext cx="261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612720"/>
                <a:tab algn="l" pos="1225440"/>
                <a:tab algn="l" pos="1838160"/>
                <a:tab algn="l" pos="2451240"/>
                <a:tab algn="l" pos="3063960"/>
                <a:tab algn="l" pos="3676680"/>
                <a:tab algn="l" pos="4289400"/>
                <a:tab algn="l" pos="4902120"/>
                <a:tab algn="l" pos="5514840"/>
                <a:tab algn="l" pos="6127920"/>
                <a:tab algn="l" pos="6740640"/>
                <a:tab algn="l" pos="7353360"/>
                <a:tab algn="l" pos="7966080"/>
                <a:tab algn="l" pos="8578800"/>
                <a:tab algn="l" pos="9191520"/>
                <a:tab algn="l" pos="9804240"/>
                <a:tab algn="l" pos="1041732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HF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53"/>
          <p:cNvSpPr/>
          <p:nvPr/>
        </p:nvSpPr>
        <p:spPr>
          <a:xfrm rot="19113000">
            <a:off x="5211720" y="3611880"/>
            <a:ext cx="681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612720"/>
                <a:tab algn="l" pos="1225440"/>
                <a:tab algn="l" pos="1838160"/>
                <a:tab algn="l" pos="2451240"/>
                <a:tab algn="l" pos="3063960"/>
                <a:tab algn="l" pos="3676680"/>
                <a:tab algn="l" pos="4289400"/>
                <a:tab algn="l" pos="4902120"/>
                <a:tab algn="l" pos="5514840"/>
                <a:tab algn="l" pos="6127920"/>
                <a:tab algn="l" pos="6740640"/>
                <a:tab algn="l" pos="7353360"/>
                <a:tab algn="l" pos="7966080"/>
                <a:tab algn="l" pos="8578800"/>
                <a:tab algn="l" pos="9191520"/>
                <a:tab algn="l" pos="9804240"/>
                <a:tab algn="l" pos="1041732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control AS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54"/>
          <p:cNvSpPr/>
          <p:nvPr/>
        </p:nvSpPr>
        <p:spPr>
          <a:xfrm rot="19113000">
            <a:off x="5794560" y="3609720"/>
            <a:ext cx="674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612720"/>
                <a:tab algn="l" pos="1225440"/>
                <a:tab algn="l" pos="1838160"/>
                <a:tab algn="l" pos="2451240"/>
                <a:tab algn="l" pos="3063960"/>
                <a:tab algn="l" pos="3676680"/>
                <a:tab algn="l" pos="4289400"/>
                <a:tab algn="l" pos="4902120"/>
                <a:tab algn="l" pos="5514840"/>
                <a:tab algn="l" pos="6127920"/>
                <a:tab algn="l" pos="6740640"/>
                <a:tab algn="l" pos="7353360"/>
                <a:tab algn="l" pos="7966080"/>
                <a:tab algn="l" pos="8578800"/>
                <a:tab algn="l" pos="9191520"/>
                <a:tab algn="l" pos="9804240"/>
                <a:tab algn="l" pos="1041732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DEP-1 AS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55"/>
          <p:cNvSpPr/>
          <p:nvPr/>
        </p:nvSpPr>
        <p:spPr>
          <a:xfrm rot="16200000">
            <a:off x="3938760" y="2481120"/>
            <a:ext cx="851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612720"/>
                <a:tab algn="l" pos="1225440"/>
                <a:tab algn="l" pos="1838160"/>
                <a:tab algn="l" pos="2451240"/>
                <a:tab algn="l" pos="3063960"/>
                <a:tab algn="l" pos="3676680"/>
                <a:tab algn="l" pos="4289400"/>
                <a:tab algn="l" pos="4902120"/>
                <a:tab algn="l" pos="5514840"/>
                <a:tab algn="l" pos="6127920"/>
                <a:tab algn="l" pos="6740640"/>
                <a:tab algn="l" pos="7353360"/>
                <a:tab algn="l" pos="7966080"/>
                <a:tab algn="l" pos="8578800"/>
                <a:tab algn="l" pos="9191520"/>
                <a:tab algn="l" pos="9804240"/>
                <a:tab algn="l" pos="1041732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arbitrary uni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6" name="Picture 58" descr=""/>
          <p:cNvPicPr/>
          <p:nvPr/>
        </p:nvPicPr>
        <p:blipFill>
          <a:blip r:embed="rId2"/>
          <a:srcRect l="19295" t="79876" r="55238" b="14482"/>
          <a:stretch/>
        </p:blipFill>
        <p:spPr>
          <a:xfrm>
            <a:off x="581040" y="3629160"/>
            <a:ext cx="2952720" cy="3124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87" name="Textfeld 56"/>
          <p:cNvSpPr/>
          <p:nvPr/>
        </p:nvSpPr>
        <p:spPr>
          <a:xfrm>
            <a:off x="3586320" y="2576520"/>
            <a:ext cx="634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pTyr 9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feld 57"/>
          <p:cNvSpPr/>
          <p:nvPr/>
        </p:nvSpPr>
        <p:spPr>
          <a:xfrm>
            <a:off x="3586320" y="3657600"/>
            <a:ext cx="706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Gerade Verbindung 59"/>
          <p:cNvSpPr/>
          <p:nvPr/>
        </p:nvSpPr>
        <p:spPr>
          <a:xfrm>
            <a:off x="3605040" y="1755720"/>
            <a:ext cx="0" cy="1728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feld 175"/>
          <p:cNvSpPr/>
          <p:nvPr/>
        </p:nvSpPr>
        <p:spPr>
          <a:xfrm>
            <a:off x="117360" y="1149480"/>
            <a:ext cx="35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feld 175"/>
          <p:cNvSpPr/>
          <p:nvPr/>
        </p:nvSpPr>
        <p:spPr>
          <a:xfrm>
            <a:off x="4235400" y="1149480"/>
            <a:ext cx="35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Gerade Verbindung 63"/>
          <p:cNvSpPr/>
          <p:nvPr/>
        </p:nvSpPr>
        <p:spPr>
          <a:xfrm>
            <a:off x="628560" y="1654200"/>
            <a:ext cx="865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Gerade Verbindung 64"/>
          <p:cNvSpPr/>
          <p:nvPr/>
        </p:nvSpPr>
        <p:spPr>
          <a:xfrm>
            <a:off x="1608120" y="1654200"/>
            <a:ext cx="865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Gerade Verbindung 65"/>
          <p:cNvSpPr/>
          <p:nvPr/>
        </p:nvSpPr>
        <p:spPr>
          <a:xfrm>
            <a:off x="2625840" y="1654200"/>
            <a:ext cx="865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feld 66"/>
          <p:cNvSpPr/>
          <p:nvPr/>
        </p:nvSpPr>
        <p:spPr>
          <a:xfrm>
            <a:off x="873000" y="142416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HF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feld 67"/>
          <p:cNvSpPr/>
          <p:nvPr/>
        </p:nvSpPr>
        <p:spPr>
          <a:xfrm>
            <a:off x="1585800" y="1424160"/>
            <a:ext cx="93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control AS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feld 68"/>
          <p:cNvSpPr/>
          <p:nvPr/>
        </p:nvSpPr>
        <p:spPr>
          <a:xfrm>
            <a:off x="2637000" y="142416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DEP-1 AS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feld 56"/>
          <p:cNvSpPr/>
          <p:nvPr/>
        </p:nvSpPr>
        <p:spPr>
          <a:xfrm>
            <a:off x="5402160" y="1328760"/>
            <a:ext cx="690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pTyr 9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Gerade Verbindung 55"/>
          <p:cNvSpPr/>
          <p:nvPr/>
        </p:nvSpPr>
        <p:spPr>
          <a:xfrm>
            <a:off x="449280" y="1905120"/>
            <a:ext cx="71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Gerade Verbindung 56"/>
          <p:cNvSpPr/>
          <p:nvPr/>
        </p:nvSpPr>
        <p:spPr>
          <a:xfrm>
            <a:off x="449280" y="2066760"/>
            <a:ext cx="71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Gerade Verbindung 57"/>
          <p:cNvSpPr/>
          <p:nvPr/>
        </p:nvSpPr>
        <p:spPr>
          <a:xfrm>
            <a:off x="449280" y="2292480"/>
            <a:ext cx="71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Gerade Verbindung 58"/>
          <p:cNvSpPr/>
          <p:nvPr/>
        </p:nvSpPr>
        <p:spPr>
          <a:xfrm>
            <a:off x="449280" y="2533680"/>
            <a:ext cx="71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Gerade Verbindung 60"/>
          <p:cNvSpPr/>
          <p:nvPr/>
        </p:nvSpPr>
        <p:spPr>
          <a:xfrm>
            <a:off x="449280" y="2859120"/>
            <a:ext cx="71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Gerade Verbindung 61"/>
          <p:cNvSpPr/>
          <p:nvPr/>
        </p:nvSpPr>
        <p:spPr>
          <a:xfrm>
            <a:off x="449280" y="3214800"/>
            <a:ext cx="71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feld 67"/>
          <p:cNvSpPr/>
          <p:nvPr/>
        </p:nvSpPr>
        <p:spPr>
          <a:xfrm>
            <a:off x="104760" y="1784520"/>
            <a:ext cx="40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17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feld 68"/>
          <p:cNvSpPr/>
          <p:nvPr/>
        </p:nvSpPr>
        <p:spPr>
          <a:xfrm>
            <a:off x="104760" y="1943280"/>
            <a:ext cx="40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1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feld 69"/>
          <p:cNvSpPr/>
          <p:nvPr/>
        </p:nvSpPr>
        <p:spPr>
          <a:xfrm>
            <a:off x="104760" y="2168640"/>
            <a:ext cx="40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feld 70"/>
          <p:cNvSpPr/>
          <p:nvPr/>
        </p:nvSpPr>
        <p:spPr>
          <a:xfrm>
            <a:off x="171360" y="2408400"/>
            <a:ext cx="328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7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feld 71"/>
          <p:cNvSpPr/>
          <p:nvPr/>
        </p:nvSpPr>
        <p:spPr>
          <a:xfrm>
            <a:off x="176040" y="2739960"/>
            <a:ext cx="333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5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feld 72"/>
          <p:cNvSpPr/>
          <p:nvPr/>
        </p:nvSpPr>
        <p:spPr>
          <a:xfrm>
            <a:off x="185760" y="3084480"/>
            <a:ext cx="333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Gerade Verbindung 73"/>
          <p:cNvSpPr/>
          <p:nvPr/>
        </p:nvSpPr>
        <p:spPr>
          <a:xfrm>
            <a:off x="450720" y="3875040"/>
            <a:ext cx="7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feld 74"/>
          <p:cNvSpPr/>
          <p:nvPr/>
        </p:nvSpPr>
        <p:spPr>
          <a:xfrm>
            <a:off x="187200" y="3746520"/>
            <a:ext cx="333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feld 66"/>
          <p:cNvSpPr/>
          <p:nvPr/>
        </p:nvSpPr>
        <p:spPr>
          <a:xfrm>
            <a:off x="104760" y="1442880"/>
            <a:ext cx="500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11T13:01:20Z</dcterms:created>
  <dc:creator>Bediener</dc:creator>
  <dc:description/>
  <dc:language>en-US</dc:language>
  <cp:lastModifiedBy>Bediener</cp:lastModifiedBy>
  <dcterms:modified xsi:type="dcterms:W3CDTF">2013-06-25T17:28:49Z</dcterms:modified>
  <cp:revision>285</cp:revision>
  <dc:subject/>
  <dc:title>Folie 1</dc:title>
</cp:coreProperties>
</file>